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217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91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318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958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792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122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14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246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634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436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084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AAED9-4408-486B-9B2F-C057D6A43948}" type="datetimeFigureOut">
              <a:rPr lang="en-US" smtClean="0"/>
              <a:t>11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28DA1-6B16-42CA-9645-DAF13BE06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393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4043841" y="276934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6190" y="3056303"/>
            <a:ext cx="1199621" cy="25487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281240" y="1316073"/>
            <a:ext cx="18620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2+ (Secretor, </a:t>
            </a:r>
            <a:r>
              <a:rPr lang="en-US" sz="1600" i="1" dirty="0" smtClean="0"/>
              <a:t>Se</a:t>
            </a:r>
            <a:r>
              <a:rPr lang="en-US" sz="1600" dirty="0" smtClean="0"/>
              <a:t>)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1666240" y="1316073"/>
            <a:ext cx="2246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2─ (Non-secretor, </a:t>
            </a:r>
            <a:r>
              <a:rPr lang="en-US" sz="1600" i="1" dirty="0" smtClean="0"/>
              <a:t>se</a:t>
            </a:r>
            <a:r>
              <a:rPr lang="en-US" sz="1600" dirty="0" smtClean="0"/>
              <a:t>)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10371215" y="2309808"/>
            <a:ext cx="14532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3+ (Lewis+)</a:t>
            </a:r>
            <a:endParaRPr lang="en-US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10375068" y="4118851"/>
            <a:ext cx="1499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3─ (Lewis─)</a:t>
            </a:r>
            <a:endParaRPr lang="en-US" sz="16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7814" y="2058907"/>
            <a:ext cx="1283623" cy="78327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9634" y="2058907"/>
            <a:ext cx="1322508" cy="77879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78367" y="2330718"/>
            <a:ext cx="267794" cy="50698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9634" y="3867950"/>
            <a:ext cx="1322508" cy="77879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3056" y="4129912"/>
            <a:ext cx="1199621" cy="254874"/>
          </a:xfrm>
          <a:prstGeom prst="rect">
            <a:avLst/>
          </a:prstGeom>
        </p:spPr>
      </p:pic>
      <p:cxnSp>
        <p:nvCxnSpPr>
          <p:cNvPr id="15" name="Straight Arrow Connector 14"/>
          <p:cNvCxnSpPr/>
          <p:nvPr/>
        </p:nvCxnSpPr>
        <p:spPr>
          <a:xfrm flipV="1">
            <a:off x="7184481" y="2584212"/>
            <a:ext cx="1025495" cy="4049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7184481" y="3381749"/>
            <a:ext cx="1025495" cy="3509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3834882" y="2520319"/>
            <a:ext cx="1025495" cy="404963"/>
          </a:xfrm>
          <a:prstGeom prst="straightConnector1">
            <a:avLst/>
          </a:prstGeom>
          <a:ln>
            <a:tailEnd type="triangle"/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3834882" y="3352841"/>
            <a:ext cx="1025495" cy="350910"/>
          </a:xfrm>
          <a:prstGeom prst="straightConnector1">
            <a:avLst/>
          </a:prstGeom>
          <a:ln>
            <a:tailEnd type="triangle"/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602820" y="3450629"/>
            <a:ext cx="9863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recursor</a:t>
            </a:r>
            <a:endParaRPr lang="en-US" sz="1600" dirty="0"/>
          </a:p>
        </p:txBody>
      </p:sp>
      <p:sp>
        <p:nvSpPr>
          <p:cNvPr id="20" name="TextBox 19"/>
          <p:cNvSpPr txBox="1"/>
          <p:nvPr/>
        </p:nvSpPr>
        <p:spPr>
          <a:xfrm>
            <a:off x="309839" y="2309808"/>
            <a:ext cx="14532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3+ (Lewis+)</a:t>
            </a:r>
            <a:endParaRPr lang="en-US" sz="1600" dirty="0"/>
          </a:p>
        </p:txBody>
      </p:sp>
      <p:sp>
        <p:nvSpPr>
          <p:cNvPr id="21" name="TextBox 20"/>
          <p:cNvSpPr txBox="1"/>
          <p:nvPr/>
        </p:nvSpPr>
        <p:spPr>
          <a:xfrm>
            <a:off x="313692" y="4118851"/>
            <a:ext cx="1499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UT3─ (Lewis─)</a:t>
            </a:r>
            <a:endParaRPr lang="en-US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8800489" y="2972623"/>
            <a:ext cx="8136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ewis b</a:t>
            </a:r>
            <a:endParaRPr lang="en-US" sz="16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382813" y="2970304"/>
            <a:ext cx="8040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ewis a</a:t>
            </a:r>
            <a:endParaRPr lang="en-US" sz="1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8322725" y="4737398"/>
            <a:ext cx="1567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H-type 1 antigen</a:t>
            </a:r>
            <a:endParaRPr lang="en-US" sz="1600" dirty="0"/>
          </a:p>
        </p:txBody>
      </p:sp>
      <p:sp>
        <p:nvSpPr>
          <p:cNvPr id="25" name="Oval 24"/>
          <p:cNvSpPr/>
          <p:nvPr/>
        </p:nvSpPr>
        <p:spPr>
          <a:xfrm>
            <a:off x="8753900" y="2943071"/>
            <a:ext cx="860209" cy="373107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2378246" y="2938070"/>
            <a:ext cx="808569" cy="373107"/>
          </a:xfrm>
          <a:prstGeom prst="ellipse">
            <a:avLst/>
          </a:prstGeom>
          <a:noFill/>
          <a:ln w="285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350157" y="5227210"/>
            <a:ext cx="114916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1. </a:t>
            </a:r>
            <a:r>
              <a:rPr lang="en-US" sz="1600" dirty="0" smtClean="0"/>
              <a:t>Simplified overview of Lewis and secretor status </a:t>
            </a:r>
            <a:r>
              <a:rPr lang="en-US" sz="1600" dirty="0" err="1" smtClean="0"/>
              <a:t>histoblood</a:t>
            </a:r>
            <a:r>
              <a:rPr lang="en-US" sz="1600" dirty="0" smtClean="0"/>
              <a:t> group antigen systems. Final antigen phenotype is determined by the combined action of the </a:t>
            </a:r>
            <a:r>
              <a:rPr lang="en-US" sz="1600" dirty="0" err="1" smtClean="0"/>
              <a:t>fucosyltransferases</a:t>
            </a:r>
            <a:r>
              <a:rPr lang="en-US" sz="1600" dirty="0" smtClean="0"/>
              <a:t> encoded by the FUT2 (secretor) and FUT3 (Lewis) genes upon Type 1 or 2 oligosaccharide precursor </a:t>
            </a:r>
            <a:r>
              <a:rPr lang="en-US" sz="1600" dirty="0" err="1" smtClean="0"/>
              <a:t>glycans</a:t>
            </a:r>
            <a:r>
              <a:rPr lang="en-US" sz="1600" dirty="0" smtClean="0"/>
              <a:t>.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655819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4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Vermon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Benjamin</dc:creator>
  <cp:lastModifiedBy>Lee, Benjamin</cp:lastModifiedBy>
  <cp:revision>1</cp:revision>
  <dcterms:created xsi:type="dcterms:W3CDTF">2017-11-14T20:43:20Z</dcterms:created>
  <dcterms:modified xsi:type="dcterms:W3CDTF">2017-11-14T20:49:24Z</dcterms:modified>
</cp:coreProperties>
</file>